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1" d="100"/>
          <a:sy n="61" d="100"/>
        </p:scale>
        <p:origin x="-1541" y="-77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494BDC-55A3-4BA8-8179-A1E1E6EBEC2C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53934C4-1469-406F-9BD4-BF976DD055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2513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6102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5253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23849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1737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3435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30073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92549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99271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72088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57303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18789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52776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87360165"/>
              </p:ext>
            </p:extLst>
          </p:nvPr>
        </p:nvGraphicFramePr>
        <p:xfrm>
          <a:off x="327540" y="230928"/>
          <a:ext cx="6264696" cy="8206680"/>
        </p:xfrm>
        <a:graphic>
          <a:graphicData uri="http://schemas.openxmlformats.org/drawingml/2006/table">
            <a:tbl>
              <a:tblPr/>
              <a:tblGrid>
                <a:gridCol w="753741"/>
                <a:gridCol w="803166"/>
                <a:gridCol w="753741"/>
                <a:gridCol w="803166"/>
                <a:gridCol w="753741"/>
                <a:gridCol w="803166"/>
                <a:gridCol w="716671"/>
                <a:gridCol w="877304"/>
              </a:tblGrid>
              <a:tr h="155443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B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ctive sarcoidosis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neumonia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ung cancer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5544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old Change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ne Symbol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old Change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ne Symbol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old Change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ne Symbol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old Change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ne Symbol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NKRD22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CGR1A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.8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LFM4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RG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.5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CGR1A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9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NKRD22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.7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TF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5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PST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.4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ERPING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4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CGR1C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.6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VNN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4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CGR1A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.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TF2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CGR1B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.4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P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2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19orf59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.9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CGR1C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4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ERPING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.3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EFA4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6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LPI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.7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CGR1B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2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CGR1B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3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PLAH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5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CGR1B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.3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NKRD22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TF2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2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EACAM8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3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L1R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.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CGR1B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5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BP5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EFA1B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CGR1C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8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728744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3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BP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LANE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DRD9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FITM3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FIT3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4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19orf59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LC26A8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5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PSTI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NKRD22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2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RG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CGR1B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7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BP5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9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728744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7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K5RAP2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LEC4D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7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FI44L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8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BP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6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EFA1B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100132858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4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BP6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8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PSTI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4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EFA3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9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LC22A4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BP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6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FI44L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3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EFA1B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8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100133177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8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400759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5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NDO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CGR1A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7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PA1L2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7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FIT3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FITM3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9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MP8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6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NXA3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6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IM2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BP6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4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CGR1B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6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IMK2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3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EPT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SAD2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3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LPI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5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MEM88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1QB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9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HRS9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2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LC26A8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5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MP9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9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BP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7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NFAIP6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PK14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5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SPRV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9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SAD2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7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FIT3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AMP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5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NSC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4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TP4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5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2RY14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7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LRC4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5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LR5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ARD17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4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HRS9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4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CAR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5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163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9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FIT3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4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DO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3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NASE3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4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AMP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6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ASP5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TAT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3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CGR1B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4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642816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4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EACAM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ARS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2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AIP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4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PRXP4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4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ARD17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2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IMM10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2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LR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4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643313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3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SG15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2RY14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CGR1C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TN3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2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FI27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389386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NXA3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RVI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IMM10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ER1L3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EFA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5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ARS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FIT3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GLYRP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OCS3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8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FI6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TP4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CN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ncRN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7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NFAIP6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O2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NKDD1A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IR2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7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STPIP2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BP4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8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L17A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2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100170939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7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FI44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FIT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8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LC26A8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2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100129904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6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O2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AP3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8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MEM144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2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RB10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6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BXO6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ASL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8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AMD14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2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SGR2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5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ER1L3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EACAM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8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PK14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2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642780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5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XCL10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IMK2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7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ETN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2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400499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3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HRS9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ASP5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7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AIP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CAR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3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AS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TAT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7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PR84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KREMEN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3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TAT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CL23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6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ASP5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LC22A4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2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P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ARS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6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PO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R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2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HRS9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F3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6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MP9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730234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2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EACAM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FI6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5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R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LC26A8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2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LC26A8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STPIP2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4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YL9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7orf53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2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ACNA1E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SPRV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2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LEC4D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</a:t>
                      </a: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VNN1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LFM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BXO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TGAX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LRC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4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POL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XCL1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NKRD2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028" marR="5028" marT="50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OC400499</a:t>
                      </a:r>
                    </a:p>
                  </a:txBody>
                  <a:tcPr marL="5028" marR="5028" marT="50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-72009" y="-82812"/>
            <a:ext cx="1268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Table </a:t>
            </a:r>
            <a:r>
              <a:rPr lang="en-GB" b="1" dirty="0" smtClean="0"/>
              <a:t>S5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29672339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424</Words>
  <Application>Microsoft Office PowerPoint</Application>
  <PresentationFormat>On-screen Show (4:3)</PresentationFormat>
  <Paragraphs>4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loom</dc:creator>
  <cp:lastModifiedBy>Bloom</cp:lastModifiedBy>
  <cp:revision>6</cp:revision>
  <dcterms:created xsi:type="dcterms:W3CDTF">2013-03-09T22:22:05Z</dcterms:created>
  <dcterms:modified xsi:type="dcterms:W3CDTF">2013-03-09T22:29:35Z</dcterms:modified>
</cp:coreProperties>
</file>